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9" r:id="rId4"/>
    <p:sldId id="260" r:id="rId5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148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7577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1087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148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0296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0773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2526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1424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7485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251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1905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6112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A7C81A-52BA-42E9-8438-6524A4E86F88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E5D5DD-3250-4136-BD04-7E465C66CF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3608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0826" y="1719889"/>
            <a:ext cx="7200000" cy="34182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ZoneTexte 2"/>
          <p:cNvSpPr txBox="1"/>
          <p:nvPr/>
        </p:nvSpPr>
        <p:spPr>
          <a:xfrm>
            <a:off x="2842071" y="0"/>
            <a:ext cx="3459858" cy="9233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b="1" u="sng" dirty="0" err="1" smtClean="0"/>
              <a:t>Supplementary</a:t>
            </a:r>
            <a:r>
              <a:rPr lang="fr-FR" b="1" u="sng" dirty="0" smtClean="0"/>
              <a:t> data : Figure 2</a:t>
            </a:r>
          </a:p>
          <a:p>
            <a:pPr algn="ctr"/>
            <a:endParaRPr lang="fr-FR" b="1" dirty="0" smtClean="0"/>
          </a:p>
          <a:p>
            <a:pPr algn="ctr"/>
            <a:r>
              <a:rPr lang="fr-FR" b="1" dirty="0" smtClean="0"/>
              <a:t>Western blot – Cx43 – DAPAT </a:t>
            </a:r>
            <a:r>
              <a:rPr lang="fr-FR" b="1" dirty="0" err="1" smtClean="0"/>
              <a:t>mice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34399068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2026143" y="0"/>
            <a:ext cx="5091715" cy="9233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b="1" u="sng" dirty="0" err="1" smtClean="0"/>
              <a:t>Supplementary</a:t>
            </a:r>
            <a:r>
              <a:rPr lang="fr-FR" b="1" u="sng" dirty="0" smtClean="0"/>
              <a:t> data : Figures 4, 5</a:t>
            </a:r>
          </a:p>
          <a:p>
            <a:pPr algn="ctr"/>
            <a:endParaRPr lang="fr-FR" b="1" dirty="0" smtClean="0"/>
          </a:p>
          <a:p>
            <a:pPr algn="ctr"/>
            <a:r>
              <a:rPr lang="fr-FR" b="1" dirty="0" smtClean="0"/>
              <a:t>Western blot – pCx43 &amp; Cx43 – primary Müller cells</a:t>
            </a:r>
            <a:endParaRPr lang="fr-FR" b="1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1581331"/>
            <a:ext cx="7200000" cy="36953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2864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20689"/>
            <a:ext cx="4320000" cy="21522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ZoneTexte 1"/>
          <p:cNvSpPr txBox="1"/>
          <p:nvPr/>
        </p:nvSpPr>
        <p:spPr>
          <a:xfrm>
            <a:off x="1547664" y="116632"/>
            <a:ext cx="14750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b="1" dirty="0" smtClean="0"/>
              <a:t>WB - DHAPAT</a:t>
            </a:r>
            <a:endParaRPr lang="fr-FR" b="1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008" y="592781"/>
            <a:ext cx="4320000" cy="21801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6228184" y="116632"/>
            <a:ext cx="120738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b="1" dirty="0" smtClean="0"/>
              <a:t>WB – Cx43</a:t>
            </a:r>
            <a:endParaRPr lang="fr-FR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1165977" y="3353675"/>
            <a:ext cx="198804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b="1" dirty="0" smtClean="0"/>
              <a:t>WB – pCx43 (S368)</a:t>
            </a:r>
            <a:endParaRPr lang="fr-FR" b="1" dirty="0"/>
          </a:p>
        </p:txBody>
      </p:sp>
      <p:sp>
        <p:nvSpPr>
          <p:cNvPr id="10" name="ZoneTexte 9"/>
          <p:cNvSpPr txBox="1"/>
          <p:nvPr/>
        </p:nvSpPr>
        <p:spPr>
          <a:xfrm>
            <a:off x="5940152" y="3353675"/>
            <a:ext cx="199926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b="1" dirty="0" smtClean="0"/>
              <a:t>WB – pCx43 (Y265)</a:t>
            </a:r>
            <a:endParaRPr lang="fr-FR" b="1" dirty="0"/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826846"/>
            <a:ext cx="4320000" cy="22606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1875" y="3778667"/>
            <a:ext cx="4320000" cy="23569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034720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970041" y="3645024"/>
            <a:ext cx="120391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b="1" dirty="0" smtClean="0"/>
              <a:t>WB - GFAP</a:t>
            </a:r>
            <a:endParaRPr lang="fr-FR" b="1" dirty="0"/>
          </a:p>
        </p:txBody>
      </p:sp>
      <p:sp>
        <p:nvSpPr>
          <p:cNvPr id="5" name="ZoneTexte 4"/>
          <p:cNvSpPr txBox="1"/>
          <p:nvPr/>
        </p:nvSpPr>
        <p:spPr>
          <a:xfrm>
            <a:off x="6252190" y="397996"/>
            <a:ext cx="163217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b="1" dirty="0" smtClean="0"/>
              <a:t>WB – </a:t>
            </a:r>
            <a:r>
              <a:rPr lang="el-GR" b="1" dirty="0" smtClean="0"/>
              <a:t>β</a:t>
            </a:r>
            <a:r>
              <a:rPr lang="fr-FR" b="1" dirty="0" smtClean="0"/>
              <a:t>-</a:t>
            </a:r>
            <a:r>
              <a:rPr lang="fr-FR" b="1" dirty="0" err="1" smtClean="0"/>
              <a:t>tubulin</a:t>
            </a:r>
            <a:endParaRPr lang="fr-FR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1575258" y="397996"/>
            <a:ext cx="141256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b="1" dirty="0" smtClean="0"/>
              <a:t>WB – </a:t>
            </a:r>
            <a:r>
              <a:rPr lang="el-GR" b="1" dirty="0" smtClean="0"/>
              <a:t>β</a:t>
            </a:r>
            <a:r>
              <a:rPr lang="fr-FR" b="1" dirty="0" smtClean="0"/>
              <a:t>-</a:t>
            </a:r>
            <a:r>
              <a:rPr lang="fr-FR" b="1" dirty="0" err="1" smtClean="0"/>
              <a:t>actin</a:t>
            </a:r>
            <a:endParaRPr lang="fr-FR" b="1" dirty="0"/>
          </a:p>
        </p:txBody>
      </p:sp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834236"/>
            <a:ext cx="4320000" cy="23878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504" y="834236"/>
            <a:ext cx="4320000" cy="23878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6216" y="4077072"/>
            <a:ext cx="4320000" cy="22943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927146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58</Words>
  <Application>Microsoft Office PowerPoint</Application>
  <PresentationFormat>Affichage à l'écran (4:3)</PresentationFormat>
  <Paragraphs>13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ECILE</dc:creator>
  <cp:lastModifiedBy>CECILE</cp:lastModifiedBy>
  <cp:revision>6</cp:revision>
  <dcterms:created xsi:type="dcterms:W3CDTF">2022-03-08T17:34:48Z</dcterms:created>
  <dcterms:modified xsi:type="dcterms:W3CDTF">2022-03-11T12:11:35Z</dcterms:modified>
</cp:coreProperties>
</file>